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4" r:id="rId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001" autoAdjust="0"/>
    <p:restoredTop sz="94452" autoAdjust="0"/>
  </p:normalViewPr>
  <p:slideViewPr>
    <p:cSldViewPr snapToGrid="0" showGuides="1">
      <p:cViewPr varScale="1">
        <p:scale>
          <a:sx n="64" d="100"/>
          <a:sy n="64" d="100"/>
        </p:scale>
        <p:origin x="-724" y="-6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04E9013-1326-4F5F-90B1-BD0F8AE80141}" type="datetimeFigureOut">
              <a:rPr lang="zh-CN" altLang="en-US" smtClean="0"/>
              <a:t>2020/3/12</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AF42EEC-254D-4E76-B698-78503C2DD980}" type="slidenum">
              <a:rPr lang="zh-CN" altLang="en-US" smtClean="0"/>
              <a:t>‹#›</a:t>
            </a:fld>
            <a:endParaRPr lang="zh-CN" altLang="en-US"/>
          </a:p>
        </p:txBody>
      </p:sp>
    </p:spTree>
    <p:extLst>
      <p:ext uri="{BB962C8B-B14F-4D97-AF65-F5344CB8AC3E}">
        <p14:creationId xmlns:p14="http://schemas.microsoft.com/office/powerpoint/2010/main" val="25845751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C00FE3BB-05FB-4F89-8E92-EE4BB3184873}"/>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xmlns="" id="{58613EE4-05A6-4061-AA6B-A3561406BA5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xmlns="" id="{FBFB3CE3-B608-4183-A82A-CA0564AB2173}"/>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5" name="页脚占位符 4">
            <a:extLst>
              <a:ext uri="{FF2B5EF4-FFF2-40B4-BE49-F238E27FC236}">
                <a16:creationId xmlns:a16="http://schemas.microsoft.com/office/drawing/2014/main" xmlns="" id="{4C4CBD74-1AFF-418F-98A2-5C0CAB6A570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491200CD-1927-440D-9702-A58AF3212D0D}"/>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23182324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DB821A24-1A19-481D-9BBF-4458EDBB47F0}"/>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xmlns="" id="{B990F8AE-869A-4303-925A-FC2A78677ED8}"/>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86603C43-125D-4BBE-A330-6093F803BC9E}"/>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5" name="页脚占位符 4">
            <a:extLst>
              <a:ext uri="{FF2B5EF4-FFF2-40B4-BE49-F238E27FC236}">
                <a16:creationId xmlns:a16="http://schemas.microsoft.com/office/drawing/2014/main" xmlns="" id="{63006130-BB25-4C4C-BC80-E7FB55D034B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9C111ECB-B319-47F4-8580-DD18317B3324}"/>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34513767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xmlns="" id="{12186526-B9E6-4968-AF8C-C5B91AE7CF53}"/>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xmlns="" id="{87ACDB55-2E9F-4E82-901E-EBB143E81DC2}"/>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3F7AE7ED-1A51-4181-9AC4-0051B92B30A2}"/>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5" name="页脚占位符 4">
            <a:extLst>
              <a:ext uri="{FF2B5EF4-FFF2-40B4-BE49-F238E27FC236}">
                <a16:creationId xmlns:a16="http://schemas.microsoft.com/office/drawing/2014/main" xmlns="" id="{7AC1CA98-2B82-43B8-BA78-F326ED0FDC5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C59A848E-F8EC-4F1E-B6A4-8724F896EE09}"/>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30952024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F19B1E05-5E2D-44EF-8B8C-8EE9E3BF760A}"/>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xmlns="" id="{C0375FE8-6359-455E-A19D-693DD478BBB0}"/>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E581665E-CE2F-47DA-AC5F-E91BC94918EE}"/>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5" name="页脚占位符 4">
            <a:extLst>
              <a:ext uri="{FF2B5EF4-FFF2-40B4-BE49-F238E27FC236}">
                <a16:creationId xmlns:a16="http://schemas.microsoft.com/office/drawing/2014/main" xmlns="" id="{9DA39A5F-14D6-404C-A443-66B36B5BD21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1E6F25DE-7443-4C55-AFE7-A3BDCDE5E2E9}"/>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4517672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F8A79CB1-6761-4375-AA1B-52005C781BD7}"/>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xmlns="" id="{1AC0114F-C128-4E93-8903-45F76864BFF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xmlns="" id="{E7776F77-A9A0-4B18-BE3E-894C32B51A48}"/>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5" name="页脚占位符 4">
            <a:extLst>
              <a:ext uri="{FF2B5EF4-FFF2-40B4-BE49-F238E27FC236}">
                <a16:creationId xmlns:a16="http://schemas.microsoft.com/office/drawing/2014/main" xmlns="" id="{CA5D3D96-88A8-4C02-A389-FC7A6A299B7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xmlns="" id="{B5E2CB97-86CA-4CBD-8BBA-056349E58DF0}"/>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27053362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D3735E74-14E4-4559-BD0E-FC1EE6471F80}"/>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xmlns="" id="{A55D314D-C68B-4152-9506-2B36DA438C6C}"/>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xmlns="" id="{A20303A9-2F95-4C7E-B6DD-1861B5A8A1DE}"/>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xmlns="" id="{53EF371B-959F-4032-B929-442E54AE5A21}"/>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6" name="页脚占位符 5">
            <a:extLst>
              <a:ext uri="{FF2B5EF4-FFF2-40B4-BE49-F238E27FC236}">
                <a16:creationId xmlns:a16="http://schemas.microsoft.com/office/drawing/2014/main" xmlns="" id="{A024E8B6-6526-42D0-8C8B-3BE36168C88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xmlns="" id="{211C70F2-4F95-422C-B08A-A476576038F8}"/>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31411230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F94A0A87-1273-463C-A9ED-D31A503961B5}"/>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xmlns="" id="{137641B3-FF86-48AD-B0E5-31F7E803A24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xmlns="" id="{F9CE0567-4376-42DA-9D80-815D13E835F5}"/>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xmlns="" id="{A69AD754-91D6-4379-9558-0D40F1050A6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xmlns="" id="{B747143D-AEFB-4D3F-A5B6-85194D6B0196}"/>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xmlns="" id="{D03949BA-C99F-46F7-83A4-624DD5DEF7E5}"/>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8" name="页脚占位符 7">
            <a:extLst>
              <a:ext uri="{FF2B5EF4-FFF2-40B4-BE49-F238E27FC236}">
                <a16:creationId xmlns:a16="http://schemas.microsoft.com/office/drawing/2014/main" xmlns="" id="{45142078-4104-4D43-9AD8-3CD15F442155}"/>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xmlns="" id="{965B79EC-8FBC-43ED-A8E9-1E07E47C7389}"/>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23147871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95A0B6BE-3A32-4016-B8AF-F4ECED92FF02}"/>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xmlns="" id="{C9AD1B1E-33C5-4EE1-B4EF-9F36C428389F}"/>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4" name="页脚占位符 3">
            <a:extLst>
              <a:ext uri="{FF2B5EF4-FFF2-40B4-BE49-F238E27FC236}">
                <a16:creationId xmlns:a16="http://schemas.microsoft.com/office/drawing/2014/main" xmlns="" id="{89C6A13A-ED08-493D-94C0-FB1944EA0B62}"/>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xmlns="" id="{69E9254E-0E6C-4BC6-8B8C-F48BDAEA231C}"/>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42463354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xmlns="" id="{D533A313-5EBB-4EA4-9D77-C99AF5D63F1A}"/>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3" name="页脚占位符 2">
            <a:extLst>
              <a:ext uri="{FF2B5EF4-FFF2-40B4-BE49-F238E27FC236}">
                <a16:creationId xmlns:a16="http://schemas.microsoft.com/office/drawing/2014/main" xmlns="" id="{FFE90A84-0788-4F6F-839B-D4AC5E2605A9}"/>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xmlns="" id="{BFFA6254-85EA-4722-8457-4323B2A1CCBD}"/>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13269984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06C4AB64-EEDF-4378-9E5F-A02308CFF97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xmlns="" id="{07BD5F5D-94D1-4B1D-8D7B-F22BBF196D3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xmlns="" id="{F6E7D2EB-E42B-4043-95A4-C5DC6AC39D9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xmlns="" id="{DE43BE18-798F-4AD9-BDB4-EBBF305517A6}"/>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6" name="页脚占位符 5">
            <a:extLst>
              <a:ext uri="{FF2B5EF4-FFF2-40B4-BE49-F238E27FC236}">
                <a16:creationId xmlns:a16="http://schemas.microsoft.com/office/drawing/2014/main" xmlns="" id="{42F1DF57-12E2-4CF2-9054-DE76B20A41F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xmlns="" id="{249EE1F0-897D-4095-8E05-0252ABBCC820}"/>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41869166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xmlns="" id="{5AE757FA-853A-4C60-AD9A-03FB302CFACA}"/>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xmlns="" id="{F2C9FA4F-5213-4A2C-B374-09BF5E1E800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xmlns="" id="{27A3303A-3EA1-444A-AB82-DEEB9B5F54F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xmlns="" id="{9E8D8AF8-7F5D-4447-8A94-588C6B62F77B}"/>
              </a:ext>
            </a:extLst>
          </p:cNvPr>
          <p:cNvSpPr>
            <a:spLocks noGrp="1"/>
          </p:cNvSpPr>
          <p:nvPr>
            <p:ph type="dt" sz="half" idx="10"/>
          </p:nvPr>
        </p:nvSpPr>
        <p:spPr/>
        <p:txBody>
          <a:bodyPr/>
          <a:lstStyle/>
          <a:p>
            <a:fld id="{281D7938-140E-4D74-8A9A-955C9C1CF19E}" type="datetimeFigureOut">
              <a:rPr lang="zh-CN" altLang="en-US" smtClean="0"/>
              <a:t>2020/3/12</a:t>
            </a:fld>
            <a:endParaRPr lang="zh-CN" altLang="en-US"/>
          </a:p>
        </p:txBody>
      </p:sp>
      <p:sp>
        <p:nvSpPr>
          <p:cNvPr id="6" name="页脚占位符 5">
            <a:extLst>
              <a:ext uri="{FF2B5EF4-FFF2-40B4-BE49-F238E27FC236}">
                <a16:creationId xmlns:a16="http://schemas.microsoft.com/office/drawing/2014/main" xmlns="" id="{B91CC48C-2E2A-4424-B690-8C050B9674F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xmlns="" id="{5AE6FE8C-6029-4B7D-8421-85C12BDB476A}"/>
              </a:ext>
            </a:extLst>
          </p:cNvPr>
          <p:cNvSpPr>
            <a:spLocks noGrp="1"/>
          </p:cNvSpPr>
          <p:nvPr>
            <p:ph type="sldNum" sz="quarter" idx="12"/>
          </p:nvPr>
        </p:nvSpPr>
        <p:spPr/>
        <p:txBody>
          <a:body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3825457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xmlns="" id="{F92B8B03-B21B-4707-A92B-948175F9472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xmlns="" id="{29DF6A0B-EBAE-493D-BAA8-6D0D4D2AB81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xmlns="" id="{2E4E0EE6-D4B9-455C-B3BF-7DCFF19EE3B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81D7938-140E-4D74-8A9A-955C9C1CF19E}" type="datetimeFigureOut">
              <a:rPr lang="zh-CN" altLang="en-US" smtClean="0"/>
              <a:t>2020/3/12</a:t>
            </a:fld>
            <a:endParaRPr lang="zh-CN" altLang="en-US"/>
          </a:p>
        </p:txBody>
      </p:sp>
      <p:sp>
        <p:nvSpPr>
          <p:cNvPr id="5" name="页脚占位符 4">
            <a:extLst>
              <a:ext uri="{FF2B5EF4-FFF2-40B4-BE49-F238E27FC236}">
                <a16:creationId xmlns:a16="http://schemas.microsoft.com/office/drawing/2014/main" xmlns="" id="{98047281-BA29-4300-AF39-DB9E95F06A0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xmlns="" id="{42F57D4F-332D-4CEF-A786-B89A5FA7E30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059FB79-187B-434A-84C4-B062D5A03486}" type="slidenum">
              <a:rPr lang="zh-CN" altLang="en-US" smtClean="0"/>
              <a:t>‹#›</a:t>
            </a:fld>
            <a:endParaRPr lang="zh-CN" altLang="en-US"/>
          </a:p>
        </p:txBody>
      </p:sp>
    </p:spTree>
    <p:extLst>
      <p:ext uri="{BB962C8B-B14F-4D97-AF65-F5344CB8AC3E}">
        <p14:creationId xmlns:p14="http://schemas.microsoft.com/office/powerpoint/2010/main" val="16782503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a:extLst>
              <a:ext uri="{FF2B5EF4-FFF2-40B4-BE49-F238E27FC236}">
                <a16:creationId xmlns:a16="http://schemas.microsoft.com/office/drawing/2014/main" xmlns="" id="{E06C4D09-37CE-4B9D-9326-221BBDB17520}"/>
              </a:ext>
            </a:extLst>
          </p:cNvPr>
          <p:cNvSpPr/>
          <p:nvPr/>
        </p:nvSpPr>
        <p:spPr>
          <a:xfrm>
            <a:off x="723186" y="335460"/>
            <a:ext cx="10498092" cy="1220847"/>
          </a:xfrm>
          <a:prstGeom prst="rect">
            <a:avLst/>
          </a:prstGeom>
        </p:spPr>
        <p:txBody>
          <a:bodyPr wrap="square">
            <a:spAutoFit/>
          </a:bodyPr>
          <a:lstStyle/>
          <a:p>
            <a:pPr algn="just">
              <a:lnSpc>
                <a:spcPts val="2200"/>
              </a:lnSpc>
              <a:spcAft>
                <a:spcPts val="0"/>
              </a:spcAft>
            </a:pPr>
            <a:r>
              <a:rPr lang="en-US" altLang="zh-CN" sz="1400" b="1" dirty="0">
                <a:latin typeface="Times New Roman" panose="02020603050405020304" pitchFamily="18" charset="0"/>
                <a:cs typeface="Times New Roman" panose="02020603050405020304" pitchFamily="18" charset="0"/>
              </a:rPr>
              <a:t>Fig. </a:t>
            </a:r>
            <a:r>
              <a:rPr lang="en-US" altLang="zh-CN" sz="1400" b="1" dirty="0" smtClean="0">
                <a:latin typeface="Times New Roman" panose="02020603050405020304" pitchFamily="18" charset="0"/>
                <a:cs typeface="Times New Roman" panose="02020603050405020304" pitchFamily="18" charset="0"/>
              </a:rPr>
              <a:t>S2  </a:t>
            </a:r>
            <a:r>
              <a:rPr lang="en-US" altLang="zh-CN" sz="1400" b="1" kern="100" dirty="0" smtClean="0">
                <a:latin typeface="Times New Roman" panose="02020603050405020304" pitchFamily="18" charset="0"/>
                <a:ea typeface="宋体" panose="02010600030101010101" pitchFamily="2" charset="-122"/>
                <a:cs typeface="Times New Roman" panose="02020603050405020304" pitchFamily="18" charset="0"/>
              </a:rPr>
              <a:t>Meta-regression </a:t>
            </a:r>
            <a:r>
              <a:rPr lang="en-US" altLang="zh-CN" sz="1400" b="1" kern="100" dirty="0">
                <a:latin typeface="Times New Roman" panose="02020603050405020304" pitchFamily="18" charset="0"/>
                <a:ea typeface="宋体" panose="02010600030101010101" pitchFamily="2" charset="-122"/>
                <a:cs typeface="Times New Roman" panose="02020603050405020304" pitchFamily="18" charset="0"/>
              </a:rPr>
              <a:t>of MMSE for </a:t>
            </a:r>
            <a:r>
              <a:rPr lang="en-US" altLang="zh-CN"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cerebrospinal fluid </a:t>
            </a:r>
            <a:r>
              <a:rPr lang="en-US" altLang="zh-CN"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Ng </a:t>
            </a:r>
            <a:r>
              <a:rPr lang="en-US" altLang="zh-CN"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levels between </a:t>
            </a:r>
            <a:r>
              <a:rPr lang="en-US" altLang="zh-CN"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MCI </a:t>
            </a:r>
            <a:r>
              <a:rPr lang="en-US" altLang="zh-CN"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patients and </a:t>
            </a:r>
            <a:r>
              <a:rPr lang="en-US" altLang="zh-CN"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HC </a:t>
            </a:r>
            <a:r>
              <a:rPr lang="en-US" altLang="zh-CN" sz="1400" b="1" kern="100" dirty="0">
                <a:solidFill>
                  <a:srgbClr val="000000"/>
                </a:solidFill>
                <a:latin typeface="Times New Roman" panose="02020603050405020304" pitchFamily="18" charset="0"/>
                <a:ea typeface="宋体" panose="02010600030101010101" pitchFamily="2" charset="-122"/>
                <a:cs typeface="Times New Roman" panose="02020603050405020304" pitchFamily="18" charset="0"/>
              </a:rPr>
              <a:t>subjects</a:t>
            </a:r>
            <a:r>
              <a:rPr lang="en-US" altLang="zh-CN" sz="1400" b="1" kern="100" dirty="0" smtClean="0">
                <a:solidFill>
                  <a:srgbClr val="000000"/>
                </a:solidFill>
                <a:latin typeface="Times New Roman" panose="02020603050405020304" pitchFamily="18" charset="0"/>
                <a:ea typeface="宋体" panose="02010600030101010101" pitchFamily="2" charset="-122"/>
                <a:cs typeface="Times New Roman" panose="02020603050405020304" pitchFamily="18" charset="0"/>
              </a:rPr>
              <a:t>. </a:t>
            </a:r>
            <a:r>
              <a:rPr lang="en-US" altLang="zh-CN" sz="1400" dirty="0">
                <a:latin typeface="Times New Roman" panose="02020603050405020304" pitchFamily="18" charset="0"/>
                <a:cs typeface="Times New Roman" panose="02020603050405020304" pitchFamily="18" charset="0"/>
              </a:rPr>
              <a:t>Data includes 1833 individuals from 14 studies. The sizes of the circles are proportional to study weight and the red line indicates the fitted curve of the relationship between SMD and MMSE. MCI, mild cognitive impairment. HC, healthy controls. CSF, cerebrospinal fluid. MMSE, Mini-Mental State Examination. SMD, standard mean difference. </a:t>
            </a:r>
            <a:endParaRPr lang="zh-CN" altLang="zh-CN" b="1"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6" name="图片 5">
            <a:extLst>
              <a:ext uri="{FF2B5EF4-FFF2-40B4-BE49-F238E27FC236}">
                <a16:creationId xmlns:a16="http://schemas.microsoft.com/office/drawing/2014/main" xmlns="" id="{AEAF34FA-1C2B-41D6-BF50-FF53B546C1E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624915" y="1727204"/>
            <a:ext cx="6942171" cy="4693475"/>
          </a:xfrm>
          <a:prstGeom prst="rect">
            <a:avLst/>
          </a:prstGeom>
        </p:spPr>
      </p:pic>
    </p:spTree>
    <p:extLst>
      <p:ext uri="{BB962C8B-B14F-4D97-AF65-F5344CB8AC3E}">
        <p14:creationId xmlns:p14="http://schemas.microsoft.com/office/powerpoint/2010/main" val="2552849602"/>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05</TotalTime>
  <Words>80</Words>
  <Application>Microsoft Office PowerPoint</Application>
  <PresentationFormat>自定义</PresentationFormat>
  <Paragraphs>1</Paragraphs>
  <Slides>1</Slides>
  <Notes>0</Notes>
  <HiddenSlides>0</HiddenSlides>
  <MMClips>0</MMClips>
  <ScaleCrop>false</ScaleCrop>
  <HeadingPairs>
    <vt:vector size="4" baseType="variant">
      <vt:variant>
        <vt:lpstr>主题</vt:lpstr>
      </vt:variant>
      <vt:variant>
        <vt:i4>1</vt:i4>
      </vt:variant>
      <vt:variant>
        <vt:lpstr>幻灯片标题</vt:lpstr>
      </vt:variant>
      <vt:variant>
        <vt:i4>1</vt:i4>
      </vt:variant>
    </vt:vector>
  </HeadingPairs>
  <TitlesOfParts>
    <vt:vector size="2" baseType="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林 华伟</dc:creator>
  <cp:lastModifiedBy>hp</cp:lastModifiedBy>
  <cp:revision>78</cp:revision>
  <dcterms:created xsi:type="dcterms:W3CDTF">2019-09-16T04:07:01Z</dcterms:created>
  <dcterms:modified xsi:type="dcterms:W3CDTF">2020-03-12T01:22:12Z</dcterms:modified>
</cp:coreProperties>
</file>